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  <p:sldId id="260" r:id="rId3"/>
    <p:sldId id="257" r:id="rId4"/>
  </p:sldIdLst>
  <p:sldSz cx="10287000" cy="6858000" type="35mm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95" d="100"/>
          <a:sy n="95" d="100"/>
        </p:scale>
        <p:origin x="102" y="2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71525" y="1122363"/>
            <a:ext cx="874395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85875" y="3602038"/>
            <a:ext cx="771525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06873-D994-4CA4-82A5-34F98FF95BA7}" type="datetimeFigureOut">
              <a:rPr lang="en-US" smtClean="0"/>
              <a:t>7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66378-6AE2-4343-9B1D-5FCB8E7261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16244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06873-D994-4CA4-82A5-34F98FF95BA7}" type="datetimeFigureOut">
              <a:rPr lang="en-US" smtClean="0"/>
              <a:t>7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66378-6AE2-4343-9B1D-5FCB8E7261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91681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361635" y="365125"/>
            <a:ext cx="2218134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07232" y="365125"/>
            <a:ext cx="6525816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06873-D994-4CA4-82A5-34F98FF95BA7}" type="datetimeFigureOut">
              <a:rPr lang="en-US" smtClean="0"/>
              <a:t>7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66378-6AE2-4343-9B1D-5FCB8E7261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16146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06873-D994-4CA4-82A5-34F98FF95BA7}" type="datetimeFigureOut">
              <a:rPr lang="en-US" smtClean="0"/>
              <a:t>7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66378-6AE2-4343-9B1D-5FCB8E7261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23215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01874" y="1709740"/>
            <a:ext cx="8872538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01874" y="4589465"/>
            <a:ext cx="8872538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06873-D994-4CA4-82A5-34F98FF95BA7}" type="datetimeFigureOut">
              <a:rPr lang="en-US" smtClean="0"/>
              <a:t>7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66378-6AE2-4343-9B1D-5FCB8E7261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32596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07231" y="1825625"/>
            <a:ext cx="4371975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794" y="1825625"/>
            <a:ext cx="4371975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06873-D994-4CA4-82A5-34F98FF95BA7}" type="datetimeFigureOut">
              <a:rPr lang="en-US" smtClean="0"/>
              <a:t>7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66378-6AE2-4343-9B1D-5FCB8E7261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02936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08571" y="365127"/>
            <a:ext cx="8872538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08572" y="1681163"/>
            <a:ext cx="4351883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08572" y="2505075"/>
            <a:ext cx="4351883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207794" y="1681163"/>
            <a:ext cx="4373315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207794" y="2505075"/>
            <a:ext cx="4373315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06873-D994-4CA4-82A5-34F98FF95BA7}" type="datetimeFigureOut">
              <a:rPr lang="en-US" smtClean="0"/>
              <a:t>7/23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66378-6AE2-4343-9B1D-5FCB8E7261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94910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06873-D994-4CA4-82A5-34F98FF95BA7}" type="datetimeFigureOut">
              <a:rPr lang="en-US" smtClean="0"/>
              <a:t>7/23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66378-6AE2-4343-9B1D-5FCB8E7261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7614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06873-D994-4CA4-82A5-34F98FF95BA7}" type="datetimeFigureOut">
              <a:rPr lang="en-US" smtClean="0"/>
              <a:t>7/23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66378-6AE2-4343-9B1D-5FCB8E7261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78993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08571" y="457200"/>
            <a:ext cx="3317825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373315" y="987427"/>
            <a:ext cx="5207794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08571" y="2057400"/>
            <a:ext cx="3317825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06873-D994-4CA4-82A5-34F98FF95BA7}" type="datetimeFigureOut">
              <a:rPr lang="en-US" smtClean="0"/>
              <a:t>7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66378-6AE2-4343-9B1D-5FCB8E7261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09646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08571" y="457200"/>
            <a:ext cx="3317825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373315" y="987427"/>
            <a:ext cx="5207794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08571" y="2057400"/>
            <a:ext cx="3317825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06873-D994-4CA4-82A5-34F98FF95BA7}" type="datetimeFigureOut">
              <a:rPr lang="en-US" smtClean="0"/>
              <a:t>7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866378-6AE2-4343-9B1D-5FCB8E7261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29578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07231" y="365127"/>
            <a:ext cx="8872538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07231" y="1825625"/>
            <a:ext cx="8872538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07231" y="6356352"/>
            <a:ext cx="23145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A06873-D994-4CA4-82A5-34F98FF95BA7}" type="datetimeFigureOut">
              <a:rPr lang="en-US" smtClean="0"/>
              <a:t>7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407569" y="6356352"/>
            <a:ext cx="3471863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265194" y="6356352"/>
            <a:ext cx="23145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866378-6AE2-4343-9B1D-5FCB8E7261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6350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图片包含 图示&#10;&#10;描述已自动生成">
            <a:extLst>
              <a:ext uri="{FF2B5EF4-FFF2-40B4-BE49-F238E27FC236}">
                <a16:creationId xmlns:a16="http://schemas.microsoft.com/office/drawing/2014/main" id="{1540A0EE-0A5D-44E7-A9A5-C98295B64B4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548"/>
          <a:stretch/>
        </p:blipFill>
        <p:spPr>
          <a:xfrm>
            <a:off x="497241" y="186522"/>
            <a:ext cx="7544103" cy="6484955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CD2E469C-302F-494C-ACF0-61187CF401C7}"/>
              </a:ext>
            </a:extLst>
          </p:cNvPr>
          <p:cNvSpPr txBox="1"/>
          <p:nvPr/>
        </p:nvSpPr>
        <p:spPr>
          <a:xfrm>
            <a:off x="8041344" y="102322"/>
            <a:ext cx="2087395" cy="50484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1000"/>
              </a:spcAft>
            </a:pPr>
            <a:r>
              <a:rPr lang="en-US" altLang="zh-CN" sz="1200" b="1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</a:t>
            </a:r>
            <a:r>
              <a:rPr lang="en-US" altLang="zh-CN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Figure</a:t>
            </a:r>
            <a:r>
              <a:rPr lang="en-US" altLang="zh-CN" sz="1200" b="1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S1. 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Histograms of </a:t>
            </a:r>
            <a:r>
              <a:rPr lang="en-US" altLang="zh-CN" sz="12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rbrD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values in ten 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molecular groups (MGs)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of </a:t>
            </a:r>
            <a:r>
              <a:rPr lang="en-US" altLang="zh-CN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Puccinia </a:t>
            </a:r>
            <a:r>
              <a:rPr lang="en-US" altLang="zh-CN" sz="12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striiformis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f. sp.</a:t>
            </a:r>
            <a:r>
              <a:rPr lang="en-US" altLang="zh-CN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tritici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calculated from 999 permutations. The observed values of </a:t>
            </a:r>
            <a:r>
              <a:rPr lang="en-US" altLang="zh-CN" sz="12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rbarD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are represented as vertical dashed lines inside or outside the distributions. The hypothesis of no linkage among markers is rejected, indicating a clonal population, </a:t>
            </a:r>
            <a:r>
              <a:rPr lang="en-US" altLang="zh-CN" sz="1200" dirty="0"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while 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the hypothesis of no linkage among markers is not rejected, indicating a sexual population. </a:t>
            </a:r>
            <a:endParaRPr lang="zh-CN" altLang="zh-CN" sz="12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132371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图片包含 日程表&#10;&#10;描述已自动生成">
            <a:extLst>
              <a:ext uri="{FF2B5EF4-FFF2-40B4-BE49-F238E27FC236}">
                <a16:creationId xmlns:a16="http://schemas.microsoft.com/office/drawing/2014/main" id="{121E0345-5C94-452B-B57C-B1F0BA98123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3577" y="242768"/>
            <a:ext cx="8412271" cy="6372463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4A1E6ED3-4A63-4614-8821-E5B0C9F9B89B}"/>
              </a:ext>
            </a:extLst>
          </p:cNvPr>
          <p:cNvSpPr txBox="1"/>
          <p:nvPr/>
        </p:nvSpPr>
        <p:spPr>
          <a:xfrm>
            <a:off x="5495192" y="4342385"/>
            <a:ext cx="3749835" cy="227850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1000"/>
              </a:spcAft>
            </a:pPr>
            <a:r>
              <a:rPr lang="en-US" altLang="zh-CN" sz="1200" b="1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</a:t>
            </a:r>
            <a:r>
              <a:rPr lang="en-US" altLang="zh-CN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Figure</a:t>
            </a:r>
            <a:r>
              <a:rPr lang="en-US" altLang="zh-CN" sz="1200" b="1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S2. </a:t>
            </a:r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Histograms of </a:t>
            </a:r>
            <a:r>
              <a:rPr lang="en-US" altLang="zh-CN" sz="12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rbrD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values of nine country populations of </a:t>
            </a:r>
            <a:r>
              <a:rPr lang="en-US" altLang="zh-CN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Puccinia </a:t>
            </a:r>
            <a:r>
              <a:rPr lang="en-US" altLang="zh-CN" sz="12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striiformis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f. sp.</a:t>
            </a:r>
            <a:r>
              <a:rPr lang="en-US" altLang="zh-CN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tritici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calculated from 999 permutations. The observed values of </a:t>
            </a:r>
            <a:r>
              <a:rPr lang="en-US" altLang="zh-CN" sz="12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rbarD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are represented as vertical dashed lines outside the distributions. The hypothesis of no linkage among markers is rejected, indicating a clonal population in each country and all isolates in this study.  </a:t>
            </a:r>
            <a:endParaRPr lang="zh-CN" altLang="zh-CN" sz="12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802146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组合 13">
            <a:extLst>
              <a:ext uri="{FF2B5EF4-FFF2-40B4-BE49-F238E27FC236}">
                <a16:creationId xmlns:a16="http://schemas.microsoft.com/office/drawing/2014/main" id="{D0A987F8-C417-4520-8293-AA5943C7DBB6}"/>
              </a:ext>
            </a:extLst>
          </p:cNvPr>
          <p:cNvGrpSpPr/>
          <p:nvPr/>
        </p:nvGrpSpPr>
        <p:grpSpPr>
          <a:xfrm>
            <a:off x="109390" y="607868"/>
            <a:ext cx="10068219" cy="4847861"/>
            <a:chOff x="0" y="869125"/>
            <a:chExt cx="10068219" cy="4847861"/>
          </a:xfrm>
        </p:grpSpPr>
        <p:pic>
          <p:nvPicPr>
            <p:cNvPr id="2" name="Picture 1" descr="A picture containing chart&#10;&#10;Description automatically generated">
              <a:extLst>
                <a:ext uri="{FF2B5EF4-FFF2-40B4-BE49-F238E27FC236}">
                  <a16:creationId xmlns:a16="http://schemas.microsoft.com/office/drawing/2014/main" id="{43342B66-AA45-4FBB-95D2-4ED98461B2C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756" r="7021"/>
            <a:stretch/>
          </p:blipFill>
          <p:spPr>
            <a:xfrm>
              <a:off x="0" y="869125"/>
              <a:ext cx="10068219" cy="4847861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34D8BD80-9DFA-49A8-A304-F74B5645FB26}"/>
                </a:ext>
              </a:extLst>
            </p:cNvPr>
            <p:cNvSpPr txBox="1"/>
            <p:nvPr/>
          </p:nvSpPr>
          <p:spPr>
            <a:xfrm>
              <a:off x="2200424" y="3727526"/>
              <a:ext cx="3291626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 fontAlgn="ctr"/>
              <a:r>
                <a:rPr lang="en-US" sz="1800" b="1" u="none" strike="noStrike" dirty="0">
                  <a:effectLst/>
                </a:rPr>
                <a:t>Ecuador (44: 2011, 2015 &amp; 2016)</a:t>
              </a:r>
              <a:endParaRPr lang="en-US" sz="18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endParaRP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E09FC0CA-8364-4970-9471-D733DCBCC2E1}"/>
                </a:ext>
              </a:extLst>
            </p:cNvPr>
            <p:cNvSpPr txBox="1"/>
            <p:nvPr/>
          </p:nvSpPr>
          <p:spPr>
            <a:xfrm>
              <a:off x="1393569" y="2764088"/>
              <a:ext cx="2612210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 fontAlgn="ctr"/>
              <a:r>
                <a:rPr lang="en-US" sz="1800" b="1" u="none" strike="noStrike" dirty="0">
                  <a:effectLst/>
                </a:rPr>
                <a:t>Mexico (91; 2015 &amp; 2016)</a:t>
              </a:r>
              <a:endParaRPr lang="en-US" sz="18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endParaRP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B7DE3907-D78F-4C9D-BAD4-E30523E18B3B}"/>
                </a:ext>
              </a:extLst>
            </p:cNvPr>
            <p:cNvSpPr txBox="1"/>
            <p:nvPr/>
          </p:nvSpPr>
          <p:spPr>
            <a:xfrm>
              <a:off x="1586683" y="2235119"/>
              <a:ext cx="2225981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 fontAlgn="ctr"/>
              <a:r>
                <a:rPr lang="en-US" sz="1800" b="1" u="none" strike="noStrike" dirty="0">
                  <a:effectLst/>
                </a:rPr>
                <a:t>US (132; 2010-2017) </a:t>
              </a:r>
              <a:endParaRPr lang="en-US" sz="18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885DDE51-5A03-4663-8BBB-E85EBA5E015E}"/>
                </a:ext>
              </a:extLst>
            </p:cNvPr>
            <p:cNvSpPr txBox="1"/>
            <p:nvPr/>
          </p:nvSpPr>
          <p:spPr>
            <a:xfrm>
              <a:off x="1110889" y="1648552"/>
              <a:ext cx="2735348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 fontAlgn="ctr"/>
              <a:r>
                <a:rPr lang="en-US" sz="1800" b="1" u="none" strike="noStrike" dirty="0">
                  <a:effectLst/>
                </a:rPr>
                <a:t>Canada (14; 2013 &amp; 2017)</a:t>
              </a:r>
              <a:endParaRPr lang="en-US" sz="18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277CD935-E2A2-4B3B-82BC-FE274002DCD3}"/>
                </a:ext>
              </a:extLst>
            </p:cNvPr>
            <p:cNvSpPr txBox="1"/>
            <p:nvPr/>
          </p:nvSpPr>
          <p:spPr>
            <a:xfrm>
              <a:off x="5948005" y="3559235"/>
              <a:ext cx="2799760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 fontAlgn="ctr"/>
              <a:r>
                <a:rPr lang="en-US" sz="1800" b="1" u="none" strike="noStrike" dirty="0">
                  <a:effectLst/>
                </a:rPr>
                <a:t>Ethiopia (65; 2013 &amp; 2014)</a:t>
              </a:r>
              <a:endParaRPr lang="en-US" sz="18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C33F36F3-C56B-46C8-97FE-8E21087BAA1C}"/>
                </a:ext>
              </a:extLst>
            </p:cNvPr>
            <p:cNvSpPr txBox="1"/>
            <p:nvPr/>
          </p:nvSpPr>
          <p:spPr>
            <a:xfrm>
              <a:off x="5034109" y="2923724"/>
              <a:ext cx="2021337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 fontAlgn="ctr"/>
              <a:r>
                <a:rPr lang="en-US" sz="1800" b="1" u="none" strike="noStrike" dirty="0">
                  <a:effectLst/>
                </a:rPr>
                <a:t>Egypt (9; 2018)</a:t>
              </a:r>
              <a:endParaRPr lang="en-US" sz="18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200AC9B5-5276-4A52-ABB8-A59FE60CABFA}"/>
                </a:ext>
              </a:extLst>
            </p:cNvPr>
            <p:cNvSpPr txBox="1"/>
            <p:nvPr/>
          </p:nvSpPr>
          <p:spPr>
            <a:xfrm>
              <a:off x="4765598" y="1800649"/>
              <a:ext cx="3486085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 fontAlgn="ctr"/>
              <a:r>
                <a:rPr lang="en-US" sz="1800" b="1" u="none" strike="noStrike" dirty="0">
                  <a:effectLst/>
                </a:rPr>
                <a:t>Italy (137; 2014 &amp; 2016-2018)</a:t>
              </a:r>
              <a:endParaRPr lang="en-US" sz="18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E7F5CC84-CAF3-41D5-9C63-86A6C2A54D8D}"/>
                </a:ext>
              </a:extLst>
            </p:cNvPr>
            <p:cNvSpPr txBox="1"/>
            <p:nvPr/>
          </p:nvSpPr>
          <p:spPr>
            <a:xfrm>
              <a:off x="6848171" y="2871706"/>
              <a:ext cx="2232481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 fontAlgn="ctr"/>
              <a:r>
                <a:rPr lang="en-US" sz="1800" b="1" u="none" strike="noStrike" dirty="0">
                  <a:effectLst/>
                </a:rPr>
                <a:t>Pakistan (8; 2012)</a:t>
              </a:r>
              <a:endParaRPr lang="en-US" sz="18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E45E6419-4DD4-4174-9909-CEAF6ADC3A67}"/>
                </a:ext>
              </a:extLst>
            </p:cNvPr>
            <p:cNvSpPr txBox="1"/>
            <p:nvPr/>
          </p:nvSpPr>
          <p:spPr>
            <a:xfrm>
              <a:off x="7964412" y="2252570"/>
              <a:ext cx="175877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 fontAlgn="ctr"/>
              <a:r>
                <a:rPr lang="en-US" sz="1800" b="1" u="none" strike="noStrike" dirty="0">
                  <a:effectLst/>
                </a:rPr>
                <a:t>China (67; 2016)</a:t>
              </a:r>
              <a:endParaRPr lang="en-US" sz="18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endParaRPr>
            </a:p>
          </p:txBody>
        </p:sp>
      </p:grpSp>
      <p:sp>
        <p:nvSpPr>
          <p:cNvPr id="13" name="文本框 12">
            <a:extLst>
              <a:ext uri="{FF2B5EF4-FFF2-40B4-BE49-F238E27FC236}">
                <a16:creationId xmlns:a16="http://schemas.microsoft.com/office/drawing/2014/main" id="{A3CEA670-CDC1-4802-9F31-D5633B219AA5}"/>
              </a:ext>
            </a:extLst>
          </p:cNvPr>
          <p:cNvSpPr txBox="1"/>
          <p:nvPr/>
        </p:nvSpPr>
        <p:spPr>
          <a:xfrm>
            <a:off x="516635" y="5470705"/>
            <a:ext cx="9660974" cy="70384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1000"/>
              </a:spcAft>
            </a:pPr>
            <a:r>
              <a:rPr lang="en-US" altLang="zh-CN" sz="1400" b="1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</a:t>
            </a:r>
            <a:r>
              <a:rPr lang="en-US" altLang="zh-CN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tary Figure S3.  </a:t>
            </a:r>
            <a:r>
              <a:rPr lang="en-US" altLang="zh-CN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Geographical distribution as well as numbers and collection years of stripe rust samples of wheat, caused by </a:t>
            </a:r>
            <a:r>
              <a:rPr lang="en-US" altLang="zh-CN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Puccinia </a:t>
            </a:r>
            <a:r>
              <a:rPr lang="en-US" altLang="zh-CN" sz="14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striiformis</a:t>
            </a:r>
            <a:r>
              <a:rPr lang="en-US" altLang="zh-CN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f. sp. </a:t>
            </a:r>
            <a:r>
              <a:rPr lang="en-US" altLang="zh-CN" sz="14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tritici</a:t>
            </a:r>
            <a:r>
              <a:rPr lang="en-US" altLang="zh-CN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. The circle size represents the relative numbers of isolates.</a:t>
            </a:r>
            <a:endParaRPr lang="zh-CN" altLang="zh-CN" sz="14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72286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51</TotalTime>
  <Words>247</Words>
  <Application>Microsoft Office PowerPoint</Application>
  <PresentationFormat>35mm Slides</PresentationFormat>
  <Paragraphs>1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u, Min</dc:creator>
  <cp:lastModifiedBy>Chen, Xianming</cp:lastModifiedBy>
  <cp:revision>20</cp:revision>
  <dcterms:created xsi:type="dcterms:W3CDTF">2021-06-19T18:20:06Z</dcterms:created>
  <dcterms:modified xsi:type="dcterms:W3CDTF">2021-07-23T19:38:54Z</dcterms:modified>
</cp:coreProperties>
</file>